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F53B2-CACD-44AC-A5AF-9B7A4FD2F0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F1B3D-B0AD-497C-9BF7-A0661EFA1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9042C-170D-4F05-A7BE-9B16E21627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2C810-EEFB-457A-A740-33DB132C2C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8CF13-42FC-429C-B757-A39B1438AE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55F0D-D3CE-489E-B368-97CF640007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3EC5C-012F-4A74-8222-C54F7B15C0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D3EAB-86D4-4FC4-95B9-4B3456065F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CA2DD-3A34-4A91-9AC5-AF18140A88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2FAC3-C457-49E1-A6BF-EA96D9A41C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55FE1-EC4F-4DCB-AFD9-2AD3C0169F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6D3CA-E9E2-4E29-9143-B60127E183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40F444-659E-421C-9BAD-5D19D9A9CA67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3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 Box 1139"/>
          <p:cNvSpPr/>
          <p:nvPr/>
        </p:nvSpPr>
        <p:spPr>
          <a:xfrm>
            <a:off x="1187280" y="981000"/>
            <a:ext cx="705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3. Summary of the linear mixed effect model of growth index (heat shock: sample size of 3630 from 30 objects, MG132: sample size of 2430 from 30 objects)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332000" y="1484280"/>
          <a:ext cx="6913440" cy="3375000"/>
        </p:xfrm>
        <a:graphic>
          <a:graphicData uri="http://schemas.openxmlformats.org/drawingml/2006/table">
            <a:tbl>
              <a:tblPr/>
              <a:tblGrid>
                <a:gridCol w="1224000"/>
                <a:gridCol w="523800"/>
                <a:gridCol w="554040"/>
                <a:gridCol w="566640"/>
                <a:gridCol w="568440"/>
                <a:gridCol w="1243080"/>
                <a:gridCol w="576000"/>
                <a:gridCol w="576360"/>
                <a:gridCol w="504720"/>
                <a:gridCol w="576360"/>
              </a:tblGrid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Heat shoc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MG1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09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Coef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(df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Coef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(df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Sample  (b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&lt; 0.01(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Sample  (b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&lt; 0.01(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RIF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6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6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28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RIF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1.30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4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29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6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3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4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3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 (b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Baseline = Treatment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&lt; 0.01(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 (b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Baseline = Treatment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&lt; 0.01(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448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9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61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24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62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28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2.76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3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2.79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1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ime (b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9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ime (b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78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*Time (b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&lt; 0.01(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*Time (b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&lt; 0.01(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15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2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15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2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30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5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30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1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45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7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45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8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60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8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Treatment60: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1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Sample*Time (b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17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Sample*Time (b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-0.01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18000" bIns="180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3T02:49:26Z</dcterms:created>
  <dc:creator>김희정</dc:creator>
  <dc:description/>
  <dc:language>en-US</dc:language>
  <cp:lastModifiedBy>김희정</cp:lastModifiedBy>
  <dcterms:modified xsi:type="dcterms:W3CDTF">2011-06-14T01:50:57Z</dcterms:modified>
  <cp:revision>200</cp:revision>
  <dc:subject/>
  <dc:title>슬라이드 1</dc:title>
</cp:coreProperties>
</file>